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24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942"/>
    <p:restoredTop sz="96327"/>
  </p:normalViewPr>
  <p:slideViewPr>
    <p:cSldViewPr snapToGrid="0">
      <p:cViewPr varScale="1">
        <p:scale>
          <a:sx n="156" d="100"/>
          <a:sy n="156" d="100"/>
        </p:scale>
        <p:origin x="184" y="4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7E35FE-4003-82A0-76E6-6BA4195C3D9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9DF8CCC-CF3E-B9A7-46BD-FA4C6B94A63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214A6E-46D4-EB38-1685-CE7729D16B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0FF2C-429A-684B-9AE8-FB334F12D7C0}" type="datetimeFigureOut">
              <a:rPr lang="en-DE" smtClean="0"/>
              <a:t>09.06.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82F866-35CB-AF6E-25D4-D202FC4F22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A1B2D0-8970-5003-1722-80AA24DC42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2FD3D-A842-C341-B717-991AF992DA73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636069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4AE034-5164-0F1E-A871-6C86F497D8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2147D7-690D-B02A-556D-B31642E68A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4C082E-33A4-6A10-7B5A-2500178B02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0FF2C-429A-684B-9AE8-FB334F12D7C0}" type="datetimeFigureOut">
              <a:rPr lang="en-DE" smtClean="0"/>
              <a:t>09.06.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CE61A6-B359-5C19-A8EE-60BF3F9D33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062F7A-DB8D-68CA-3177-863C1DAB05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2FD3D-A842-C341-B717-991AF992DA73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7313459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25AC847-488B-9012-A461-8BDCD56BC29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E4C3108-DE5D-47A7-3DA6-B30F2F994C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748AA4-D0F5-21E2-6845-0730C8FBFF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0FF2C-429A-684B-9AE8-FB334F12D7C0}" type="datetimeFigureOut">
              <a:rPr lang="en-DE" smtClean="0"/>
              <a:t>09.06.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1EDB64-AC76-96B3-BE83-86D3106040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C58927-0CF6-A67A-EBC7-6E388871A4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2FD3D-A842-C341-B717-991AF992DA73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0509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07794A-77E9-CC98-F8E1-5ED3729BBF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184D70-64CB-5E2E-0B00-CC3652EC09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8537AE-136F-C82D-C3C5-74A421538D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0FF2C-429A-684B-9AE8-FB334F12D7C0}" type="datetimeFigureOut">
              <a:rPr lang="en-DE" smtClean="0"/>
              <a:t>09.06.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971AC1-09E0-25F4-7660-A6F1526E2D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810D20-653B-EC27-C22A-5AC4364C74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2FD3D-A842-C341-B717-991AF992DA73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9980230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D0DAE1-B6F7-2555-E149-DF0630CEAD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A9171A-A479-BEE4-5F97-CADF4569A6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45EFCE-03DB-AE45-E2DE-E516DF0DC3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0FF2C-429A-684B-9AE8-FB334F12D7C0}" type="datetimeFigureOut">
              <a:rPr lang="en-DE" smtClean="0"/>
              <a:t>09.06.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0C90D2-63A4-3B6C-99D4-FC5D04ACB7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FB80FE-4279-9498-B9BD-4AAFB75857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2FD3D-A842-C341-B717-991AF992DA73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9648710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A9B887-D8D3-5F7E-0358-5FB7B64373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C28868-B807-CA62-E8C4-868F2C11F09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5BB4A71-49FD-D245-540E-7EC112F2DD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604AF1-91FE-242B-1D18-2DE215F57C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0FF2C-429A-684B-9AE8-FB334F12D7C0}" type="datetimeFigureOut">
              <a:rPr lang="en-DE" smtClean="0"/>
              <a:t>09.06.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C5D925-0BCE-D6D5-7CE3-55272396F0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7F43AC-5EFD-7E70-58EB-D26558F420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2FD3D-A842-C341-B717-991AF992DA73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026115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A843C4-B970-C690-2031-EB644952BE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FCEB97-73C5-BC43-AA58-E74A1D796D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EEDF8D7-7A78-9C40-1369-0CE114E0A7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CC45075-4A5C-6222-4474-B7E336B2913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ABF9F57-A45D-F80A-15DA-2B401095D8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4B0FA97-E1EB-08E3-575A-66F29A61B9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0FF2C-429A-684B-9AE8-FB334F12D7C0}" type="datetimeFigureOut">
              <a:rPr lang="en-DE" smtClean="0"/>
              <a:t>09.06.24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6CC87B0-C12E-F154-1C50-508DD8AA2E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F748ABD-651C-78EE-A640-9392B450C5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2FD3D-A842-C341-B717-991AF992DA73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0141197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C1896A-86EB-33D8-8900-BC37A47BB6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9599D1E-A275-206E-D612-CA44F0EF37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0FF2C-429A-684B-9AE8-FB334F12D7C0}" type="datetimeFigureOut">
              <a:rPr lang="en-DE" smtClean="0"/>
              <a:t>09.06.24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05BC875-D345-2ACD-B599-EC9823EE7F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E857746-ED1D-22E4-A60F-06AA6A83F8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2FD3D-A842-C341-B717-991AF992DA73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228120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5954B6F-D35F-09A3-7E59-2840DC403C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0FF2C-429A-684B-9AE8-FB334F12D7C0}" type="datetimeFigureOut">
              <a:rPr lang="en-DE" smtClean="0"/>
              <a:t>09.06.24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313718A-0255-7116-B6BE-C06720876B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7B41D6B-C234-95AB-ACEB-2A64BCF353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2FD3D-A842-C341-B717-991AF992DA73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5092084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D5B785-3B1B-9E39-DDA1-5406B9DDEC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CC36F0-98D2-85F4-3B7B-98AA97DEA7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0C5DAA7-A61B-7548-958F-E4A278EC32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DF284B8-48AA-DF9C-ADBA-4FD1966ACA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0FF2C-429A-684B-9AE8-FB334F12D7C0}" type="datetimeFigureOut">
              <a:rPr lang="en-DE" smtClean="0"/>
              <a:t>09.06.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FE439D-87D1-1DA5-110C-6B4230D109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785DA9-4E83-48C0-26B1-FCEF32AB1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2FD3D-A842-C341-B717-991AF992DA73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126357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9531D8-2954-562E-D5A5-38B3CCB46A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B5AAD26-2D05-C8E0-A137-7049CD30C39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6B65ED9-B8B6-5AE2-316B-41F687121C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9706F2F-435F-E96B-C07B-81EAF3D71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00FF2C-429A-684B-9AE8-FB334F12D7C0}" type="datetimeFigureOut">
              <a:rPr lang="en-DE" smtClean="0"/>
              <a:t>09.06.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2DF7B82-F4DA-2073-6AA2-2B753EFFDB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BB4504-AE1F-C26C-252C-6947775AA1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2FD3D-A842-C341-B717-991AF992DA73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9523936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958B03A-55C5-24B9-432F-5D9DA85101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BFFDF8-A500-FDE9-D249-F8BD037E19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1C4EC4-45E1-F3D9-FEDC-C5CB0345CAC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00FF2C-429A-684B-9AE8-FB334F12D7C0}" type="datetimeFigureOut">
              <a:rPr lang="en-DE" smtClean="0"/>
              <a:t>09.06.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A208F8-9A05-2E4A-CEAB-016ED7E18BF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ADE2E5-59EC-2684-FA15-02C61A48C52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A2FD3D-A842-C341-B717-991AF992DA73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058566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5144292-5A00-0D9B-34C0-38F93E9C6D6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85712" y="1094005"/>
            <a:ext cx="4168636" cy="313481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BBA039B-ED33-8322-440B-B57EE3DE6F0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68077" y="1094003"/>
            <a:ext cx="3690994" cy="313481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CE1117D-C75A-71D7-9763-82EEE63D9F2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85712" y="4299235"/>
            <a:ext cx="8012419" cy="1539642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FC342A0-5234-874D-BF28-9CADBA165FCE}"/>
              </a:ext>
            </a:extLst>
          </p:cNvPr>
          <p:cNvSpPr txBox="1"/>
          <p:nvPr/>
        </p:nvSpPr>
        <p:spPr>
          <a:xfrm>
            <a:off x="1885712" y="1092037"/>
            <a:ext cx="224538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sz="2100" b="1" dirty="0">
                <a:solidFill>
                  <a:schemeClr val="bg1"/>
                </a:solidFill>
              </a:rPr>
              <a:t>a</a:t>
            </a:r>
            <a:endParaRPr lang="en-DE" sz="1588" b="1" dirty="0">
              <a:solidFill>
                <a:schemeClr val="bg1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268CF76-4859-B885-F071-FEB573652E29}"/>
              </a:ext>
            </a:extLst>
          </p:cNvPr>
          <p:cNvSpPr txBox="1"/>
          <p:nvPr/>
        </p:nvSpPr>
        <p:spPr>
          <a:xfrm>
            <a:off x="1885712" y="4228819"/>
            <a:ext cx="224538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sz="2100" b="1" dirty="0">
                <a:solidFill>
                  <a:schemeClr val="bg1"/>
                </a:solidFill>
              </a:rPr>
              <a:t>c</a:t>
            </a:r>
            <a:endParaRPr lang="en-DE" sz="1588" b="1" dirty="0">
              <a:solidFill>
                <a:schemeClr val="bg1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0A95039-9EF8-B829-9ADC-C287F08870C6}"/>
              </a:ext>
            </a:extLst>
          </p:cNvPr>
          <p:cNvSpPr txBox="1"/>
          <p:nvPr/>
        </p:nvSpPr>
        <p:spPr>
          <a:xfrm>
            <a:off x="6137655" y="1092037"/>
            <a:ext cx="224538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DE" sz="2100" b="1" dirty="0">
                <a:solidFill>
                  <a:schemeClr val="bg1"/>
                </a:solidFill>
              </a:rPr>
              <a:t>b</a:t>
            </a:r>
            <a:endParaRPr lang="en-DE" sz="1588" b="1" dirty="0">
              <a:solidFill>
                <a:schemeClr val="bg1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1CEA0C12-3682-089B-2FF2-5E462AAC9810}"/>
              </a:ext>
            </a:extLst>
          </p:cNvPr>
          <p:cNvSpPr txBox="1"/>
          <p:nvPr/>
        </p:nvSpPr>
        <p:spPr>
          <a:xfrm>
            <a:off x="1885711" y="6052930"/>
            <a:ext cx="801241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ree different morphological evaluation methods of IOLs with light microscopy (Fig. 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darkfield microscopy (Fig.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SS-OCT (Fig.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en-DE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DE" dirty="0"/>
          </a:p>
        </p:txBody>
      </p:sp>
    </p:spTree>
    <p:extLst>
      <p:ext uri="{BB962C8B-B14F-4D97-AF65-F5344CB8AC3E}">
        <p14:creationId xmlns:p14="http://schemas.microsoft.com/office/powerpoint/2010/main" val="28551844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2</Words>
  <Application>Microsoft Macintosh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nberk Goktepe</dc:creator>
  <cp:lastModifiedBy>Canberk Goktepe</cp:lastModifiedBy>
  <cp:revision>2</cp:revision>
  <dcterms:created xsi:type="dcterms:W3CDTF">2023-08-05T18:54:58Z</dcterms:created>
  <dcterms:modified xsi:type="dcterms:W3CDTF">2024-06-09T19:33:36Z</dcterms:modified>
</cp:coreProperties>
</file>